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="" xmlns:a16="http://schemas.microsoft.com/office/drawing/2014/main" id="{62C173E9-D46A-444F-8267-CA128DEA506D}"/>
              </a:ext>
            </a:extLst>
          </p:cNvPr>
          <p:cNvSpPr/>
          <p:nvPr/>
        </p:nvSpPr>
        <p:spPr>
          <a:xfrm>
            <a:off x="1533939" y="372871"/>
            <a:ext cx="9124122" cy="9079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3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  Funnel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plot for Ng levels in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AD vs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CI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ircles indicate individual studies. The solid line indicates the combined SMD and the dotted line indicates the 95% CI. AD, Alzheimer’s disease. MCI, mild cognitive impairment. SMD, standard mean difference. CI, confidence interval. se, standard error.</a:t>
            </a:r>
            <a:endParaRPr lang="zh-CN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zh-CN" altLang="zh-CN" sz="1100" b="1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41ED6DE9-EF19-4CB5-8696-67D6EBF6F54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1363" y="1242391"/>
            <a:ext cx="6540567" cy="48262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7509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4</TotalTime>
  <Words>64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7</cp:revision>
  <dcterms:created xsi:type="dcterms:W3CDTF">2019-09-16T04:07:01Z</dcterms:created>
  <dcterms:modified xsi:type="dcterms:W3CDTF">2020-03-12T01:19:24Z</dcterms:modified>
</cp:coreProperties>
</file>